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Default Extension="png" ContentType="image/png"/>
  <Override PartName="/ppt/slides/slide11.xml" ContentType="application/vnd.openxmlformats-officedocument.presentationml.slide+xml"/>
  <Default Extension="xml" ContentType="application/xml"/>
  <Override PartName="/ppt/slides/slide9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s/slide18.xml" ContentType="application/vnd.openxmlformats-officedocument.presentationml.slide+xml"/>
  <Override PartName="/ppt/slides/slide23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ppt/slides/slide16.xml" ContentType="application/vnd.openxmlformats-officedocument.presentationml.slide+xml"/>
  <Override PartName="/ppt/slides/slide2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ppt/slides/slide14.xml" ContentType="application/vnd.openxmlformats-officedocument.presentationml.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Override PartName="/ppt/slides/slide12.xml" ContentType="application/vnd.openxmlformats-officedocument.presentationml.slide+xml"/>
  <Default Extension="bin" ContentType="application/vnd.openxmlformats-officedocument.presentationml.printerSettings"/>
  <Override PartName="/ppt/slides/slide10.xml" ContentType="application/vnd.openxmlformats-officedocument.presentationml.slide+xml"/>
  <Override PartName="/ppt/viewProps.xml" ContentType="application/vnd.openxmlformats-officedocument.presentationml.viewProps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slides/slide19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s/slide17.xml" ContentType="application/vnd.openxmlformats-officedocument.presentationml.slide+xml"/>
  <Override PartName="/ppt/slides/slide22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s/slide20.xml" ContentType="application/vnd.openxmlformats-officedocument.presentationml.slide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  <Override PartName="/ppt/slides/slide13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  <p:sldId id="258" r:id="rId3"/>
    <p:sldId id="263" r:id="rId4"/>
    <p:sldId id="259" r:id="rId5"/>
    <p:sldId id="260" r:id="rId6"/>
    <p:sldId id="261" r:id="rId7"/>
    <p:sldId id="262" r:id="rId8"/>
    <p:sldId id="257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>
          <a:srgbClr val="FF0000"/>
        </p14:laserClr>
      </p:ext>
      <p:ext uri="{2FDB2607-1784-4EEB-B798-7EB5836EED8A}">
        <p14:showMediaCtrls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"/>
      </p:ext>
    </p:extLst>
  </p:showPr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  <p:ext uri="{FD5EFAAD-0ECE-453E-9831-46B23BE46B34}">
      <p15:chartTrackingRefBased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8" d="100"/>
          <a:sy n="88" d="100"/>
        </p:scale>
        <p:origin x="-112" y="-6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printerSettings" Target="printerSettings/printerSettings1.bin"/><Relationship Id="rId26" Type="http://schemas.openxmlformats.org/officeDocument/2006/relationships/presProps" Target="presProps.xml"/><Relationship Id="rId27" Type="http://schemas.openxmlformats.org/officeDocument/2006/relationships/viewProps" Target="viewProps.xml"/><Relationship Id="rId28" Type="http://schemas.openxmlformats.org/officeDocument/2006/relationships/theme" Target="theme/theme1.xml"/><Relationship Id="rId29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02415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13576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375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80647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664687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8115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832549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64579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15229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5722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74242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6ADE3-8C64-4EC7-B17A-B1E2D816A03C}" type="datetimeFigureOut">
              <a:rPr lang="en-US" smtClean="0"/>
              <a:pPr/>
              <a:t>7/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208591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0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1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H4 peptides with PTM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826772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17421" cy="6858000"/>
            <a:chOff x="-1" y="0"/>
            <a:chExt cx="931742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445" t="9895" r="30868" b="14584"/>
            <a:stretch/>
          </p:blipFill>
          <p:spPr>
            <a:xfrm>
              <a:off x="-1" y="0"/>
              <a:ext cx="931742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200" y="3429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255990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71000" cy="6796645"/>
            <a:chOff x="0" y="-1"/>
            <a:chExt cx="9271000" cy="679664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50" t="10589" r="30966" b="14063"/>
            <a:stretch/>
          </p:blipFill>
          <p:spPr>
            <a:xfrm>
              <a:off x="0" y="-1"/>
              <a:ext cx="9271000" cy="679664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556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3260144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290471" cy="6858000"/>
            <a:chOff x="-1" y="0"/>
            <a:chExt cx="929047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1285" r="30869" b="12847"/>
            <a:stretch/>
          </p:blipFill>
          <p:spPr>
            <a:xfrm>
              <a:off x="-1" y="0"/>
              <a:ext cx="929047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350024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21858" cy="6858000"/>
            <a:chOff x="0" y="0"/>
            <a:chExt cx="932185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49" t="10069" r="30771" b="14063"/>
            <a:stretch/>
          </p:blipFill>
          <p:spPr>
            <a:xfrm>
              <a:off x="0" y="0"/>
              <a:ext cx="932185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03283694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10302586" cy="6858000"/>
            <a:chOff x="0" y="0"/>
            <a:chExt cx="10302586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444" t="10069" r="24036" b="13542"/>
            <a:stretch/>
          </p:blipFill>
          <p:spPr>
            <a:xfrm>
              <a:off x="0" y="0"/>
              <a:ext cx="10302586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7100" y="4064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475138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26255" cy="6858000"/>
            <a:chOff x="-1" y="0"/>
            <a:chExt cx="932625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2" t="10243" r="28917" b="13542"/>
            <a:stretch/>
          </p:blipFill>
          <p:spPr>
            <a:xfrm>
              <a:off x="-1" y="0"/>
              <a:ext cx="932625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71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152479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425836" cy="6858000"/>
            <a:chOff x="0" y="0"/>
            <a:chExt cx="9425836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2" t="9722" r="28527" b="14237"/>
            <a:stretch/>
          </p:blipFill>
          <p:spPr>
            <a:xfrm>
              <a:off x="0" y="0"/>
              <a:ext cx="9425836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6630466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88743" cy="6858000"/>
            <a:chOff x="-1" y="0"/>
            <a:chExt cx="938874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1" t="10417" r="28527" b="13368"/>
            <a:stretch/>
          </p:blipFill>
          <p:spPr>
            <a:xfrm>
              <a:off x="-1" y="0"/>
              <a:ext cx="938874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90214306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18315" cy="6858000"/>
            <a:chOff x="-1" y="0"/>
            <a:chExt cx="1031831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639" t="10243" r="24036" b="13715"/>
            <a:stretch/>
          </p:blipFill>
          <p:spPr>
            <a:xfrm>
              <a:off x="-1" y="0"/>
              <a:ext cx="1031831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517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978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2166005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89007" cy="6858000"/>
            <a:chOff x="-1" y="0"/>
            <a:chExt cx="1038900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0069" r="24036" b="14063"/>
            <a:stretch/>
          </p:blipFill>
          <p:spPr>
            <a:xfrm>
              <a:off x="-1" y="0"/>
              <a:ext cx="1038900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613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48118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96400" cy="6871252"/>
            <a:chOff x="0" y="0"/>
            <a:chExt cx="9296400" cy="687125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957" t="11633" r="30673" b="11631"/>
            <a:stretch/>
          </p:blipFill>
          <p:spPr>
            <a:xfrm>
              <a:off x="0" y="0"/>
              <a:ext cx="9296400" cy="6871252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8099699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0"/>
            <a:ext cx="11471849" cy="6858000"/>
            <a:chOff x="0" y="0"/>
            <a:chExt cx="11471849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444" t="10764" r="17203" b="13368"/>
            <a:stretch/>
          </p:blipFill>
          <p:spPr>
            <a:xfrm>
              <a:off x="0" y="0"/>
              <a:ext cx="11471849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8740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84201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7251700" y="330200"/>
              <a:ext cx="571500" cy="177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243079" y="5251574"/>
              <a:ext cx="101600" cy="2226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100165" y="5247422"/>
              <a:ext cx="101600" cy="2226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61118101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400325" cy="6858000"/>
            <a:chOff x="-1" y="0"/>
            <a:chExt cx="940032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8" t="10243" r="28624" b="13889"/>
            <a:stretch/>
          </p:blipFill>
          <p:spPr>
            <a:xfrm>
              <a:off x="-1" y="0"/>
              <a:ext cx="940032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1249034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631466" cy="6858000"/>
            <a:chOff x="0" y="0"/>
            <a:chExt cx="10631466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11459" r="20815" b="12500"/>
            <a:stretch/>
          </p:blipFill>
          <p:spPr>
            <a:xfrm>
              <a:off x="0" y="0"/>
              <a:ext cx="10631466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8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9756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6994362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33973" cy="6858000"/>
            <a:chOff x="-1" y="0"/>
            <a:chExt cx="1033397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542" t="11111" r="24036" b="12848"/>
            <a:stretch/>
          </p:blipFill>
          <p:spPr>
            <a:xfrm>
              <a:off x="-1" y="0"/>
              <a:ext cx="1033397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71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359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02920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290471" cy="6858000"/>
            <a:chOff x="-1" y="0"/>
            <a:chExt cx="929047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0069" r="30869" b="14063"/>
            <a:stretch/>
          </p:blipFill>
          <p:spPr>
            <a:xfrm>
              <a:off x="-1" y="0"/>
              <a:ext cx="929047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708137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16233" cy="6858000"/>
            <a:chOff x="-1" y="0"/>
            <a:chExt cx="931623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2" t="10764" r="29112" b="13194"/>
            <a:stretch/>
          </p:blipFill>
          <p:spPr>
            <a:xfrm>
              <a:off x="-1" y="0"/>
              <a:ext cx="931623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491247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20200" cy="6860454"/>
            <a:chOff x="0" y="0"/>
            <a:chExt cx="9220200" cy="686045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1459" r="31064" b="12326"/>
            <a:stretch/>
          </p:blipFill>
          <p:spPr>
            <a:xfrm>
              <a:off x="0" y="0"/>
              <a:ext cx="9220200" cy="6860454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812103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1000" cy="6863354"/>
            <a:chOff x="0" y="0"/>
            <a:chExt cx="9271000" cy="686335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3006" t="11805" r="29112" b="11979"/>
            <a:stretch/>
          </p:blipFill>
          <p:spPr>
            <a:xfrm>
              <a:off x="0" y="0"/>
              <a:ext cx="9271000" cy="6863354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7100" y="3556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693860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83700" cy="6834051"/>
            <a:chOff x="0" y="-1"/>
            <a:chExt cx="9283700" cy="683405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8" t="10764" r="29404" b="13194"/>
            <a:stretch/>
          </p:blipFill>
          <p:spPr>
            <a:xfrm>
              <a:off x="0" y="-1"/>
              <a:ext cx="9283700" cy="683405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488281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259085" cy="6858000"/>
            <a:chOff x="-1" y="0"/>
            <a:chExt cx="925908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543" t="10069" r="30868" b="14063"/>
            <a:stretch/>
          </p:blipFill>
          <p:spPr>
            <a:xfrm>
              <a:off x="-1" y="0"/>
              <a:ext cx="925908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042935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89007" cy="6858000"/>
            <a:chOff x="-1" y="0"/>
            <a:chExt cx="1038900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50" t="10069" r="24133" b="14063"/>
            <a:stretch/>
          </p:blipFill>
          <p:spPr>
            <a:xfrm>
              <a:off x="-1" y="0"/>
              <a:ext cx="1038900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867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459273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:a="http://schemas.openxmlformats.org/drawingml/2006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4</Words>
  <Application>Microsoft Macintosh PowerPoint</Application>
  <PresentationFormat>Custom</PresentationFormat>
  <Paragraphs>1</Paragraphs>
  <Slides>23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4" baseType="lpstr">
      <vt:lpstr>Office Theme</vt:lpstr>
      <vt:lpstr>H4 peptides with PTMs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4 peptides with PTMs</dc:title>
  <dc:creator>Xuemei</dc:creator>
  <cp:lastModifiedBy>Diana Chu</cp:lastModifiedBy>
  <cp:revision>12</cp:revision>
  <dcterms:created xsi:type="dcterms:W3CDTF">2014-07-04T06:27:40Z</dcterms:created>
  <dcterms:modified xsi:type="dcterms:W3CDTF">2014-07-04T06:29:00Z</dcterms:modified>
</cp:coreProperties>
</file>